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sldIdLst>
    <p:sldId id="280" r:id="rId5"/>
    <p:sldId id="256" r:id="rId6"/>
    <p:sldId id="257" r:id="rId7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10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SUOC%20UTUC&#20104;&#24460;&#22240;&#23376;&#30740;&#31350;%20IJU&#25237;&#31295;&#29992;&#12501;&#12449;&#12452;&#12523;&#65297;\CM274%20unfit&#30151;&#20363;&#12395;&#12362;&#12369;&#12427;&#12522;&#12473;&#12463;&#22240;&#23376;&#12358;&#12385;&#12431;&#12369;&#20316;&#25104;&#29992;&#12501;&#12449;&#12452;&#12523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SUOC%20UTUC&#20104;&#24460;&#22240;&#23376;&#30740;&#31350;%20IJU&#25237;&#31295;&#29992;&#12501;&#12449;&#12452;&#12523;&#65297;\CM274%20unfit&#30151;&#20363;&#12395;&#12362;&#12369;&#12427;&#12522;&#12473;&#12463;&#22240;&#23376;&#12358;&#12385;&#12431;&#12369;&#20316;&#25104;&#29992;&#12501;&#12449;&#12452;&#12523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SUOC%20UTUC&#20104;&#24460;&#22240;&#23376;&#30740;&#31350;%20IJU&#25237;&#31295;&#29992;&#12501;&#12449;&#12452;&#12523;&#65297;\CM274%20unfit&#30151;&#20363;&#12395;&#12362;&#12369;&#12427;&#12522;&#12473;&#12463;&#22240;&#23376;&#12358;&#12385;&#12431;&#12369;&#20316;&#25104;&#29992;&#12501;&#12449;&#12452;&#12523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8</c:f>
              <c:strCache>
                <c:ptCount val="1"/>
                <c:pt idx="0">
                  <c:v>preoperative URS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9</c:f>
              <c:strCache>
                <c:ptCount val="1"/>
                <c:pt idx="0">
                  <c:v>1 risk </c:v>
                </c:pt>
              </c:strCache>
            </c:strRef>
          </c:cat>
          <c:val>
            <c:numRef>
              <c:f>Sheet1!$B$9</c:f>
              <c:numCache>
                <c:formatCode>General</c:formatCode>
                <c:ptCount val="1"/>
                <c:pt idx="0">
                  <c:v>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EB-495C-BD4F-5613BD3B0BCE}"/>
            </c:ext>
          </c:extLst>
        </c:ser>
        <c:ser>
          <c:idx val="1"/>
          <c:order val="1"/>
          <c:tx>
            <c:strRef>
              <c:f>Sheet1!$C$8</c:f>
              <c:strCache>
                <c:ptCount val="1"/>
                <c:pt idx="0">
                  <c:v>≧pT2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9</c:f>
              <c:strCache>
                <c:ptCount val="1"/>
                <c:pt idx="0">
                  <c:v>1 risk </c:v>
                </c:pt>
              </c:strCache>
            </c:strRef>
          </c:cat>
          <c:val>
            <c:numRef>
              <c:f>Sheet1!$C$9</c:f>
              <c:numCache>
                <c:formatCode>General</c:formatCode>
                <c:ptCount val="1"/>
                <c:pt idx="0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EB-495C-BD4F-5613BD3B0BCE}"/>
            </c:ext>
          </c:extLst>
        </c:ser>
        <c:ser>
          <c:idx val="2"/>
          <c:order val="2"/>
          <c:tx>
            <c:strRef>
              <c:f>Sheet1!$D$8</c:f>
              <c:strCache>
                <c:ptCount val="1"/>
                <c:pt idx="0">
                  <c:v>LVI(+)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9</c:f>
              <c:strCache>
                <c:ptCount val="1"/>
                <c:pt idx="0">
                  <c:v>1 risk </c:v>
                </c:pt>
              </c:strCache>
            </c:strRef>
          </c:cat>
          <c:val>
            <c:numRef>
              <c:f>Sheet1!$D$9</c:f>
              <c:numCache>
                <c:formatCode>General</c:formatCode>
                <c:ptCount val="1"/>
                <c:pt idx="0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8EB-495C-BD4F-5613BD3B0BCE}"/>
            </c:ext>
          </c:extLst>
        </c:ser>
        <c:ser>
          <c:idx val="3"/>
          <c:order val="3"/>
          <c:tx>
            <c:strRef>
              <c:f>Sheet1!$E$8</c:f>
              <c:strCache>
                <c:ptCount val="1"/>
                <c:pt idx="0">
                  <c:v>VH(+)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satMod val="103000"/>
                    <a:lumMod val="102000"/>
                    <a:tint val="94000"/>
                  </a:schemeClr>
                </a:gs>
                <a:gs pos="50000">
                  <a:schemeClr val="accent4">
                    <a:satMod val="110000"/>
                    <a:lumMod val="100000"/>
                    <a:shade val="100000"/>
                  </a:schemeClr>
                </a:gs>
                <a:gs pos="100000">
                  <a:schemeClr val="accent4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9</c:f>
              <c:strCache>
                <c:ptCount val="1"/>
                <c:pt idx="0">
                  <c:v>1 risk </c:v>
                </c:pt>
              </c:strCache>
            </c:strRef>
          </c:cat>
          <c:val>
            <c:numRef>
              <c:f>Sheet1!$E$9</c:f>
              <c:numCache>
                <c:formatCode>General</c:formatCode>
                <c:ptCount val="1"/>
                <c:pt idx="0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8EB-495C-BD4F-5613BD3B0B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26939000"/>
        <c:axId val="1326938280"/>
      </c:barChart>
      <c:catAx>
        <c:axId val="1326939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26938280"/>
        <c:crosses val="autoZero"/>
        <c:auto val="1"/>
        <c:lblAlgn val="ctr"/>
        <c:lblOffset val="100"/>
        <c:noMultiLvlLbl val="0"/>
      </c:catAx>
      <c:valAx>
        <c:axId val="13269382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2693900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11</c:f>
              <c:strCache>
                <c:ptCount val="1"/>
                <c:pt idx="0">
                  <c:v>≧pT2+preoperative URS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Sheet1!$B$12</c:f>
              <c:numCache>
                <c:formatCode>General</c:formatCode>
                <c:ptCount val="1"/>
                <c:pt idx="0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AC-4BBF-BE11-2CA71BFC32FA}"/>
            </c:ext>
          </c:extLst>
        </c:ser>
        <c:ser>
          <c:idx val="1"/>
          <c:order val="1"/>
          <c:tx>
            <c:strRef>
              <c:f>Sheet1!$C$11</c:f>
              <c:strCache>
                <c:ptCount val="1"/>
                <c:pt idx="0">
                  <c:v>≧pT2+LVI(+)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Sheet1!$C$12</c:f>
              <c:numCache>
                <c:formatCode>General</c:formatCode>
                <c:ptCount val="1"/>
                <c:pt idx="0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AC-4BBF-BE11-2CA71BFC32FA}"/>
            </c:ext>
          </c:extLst>
        </c:ser>
        <c:ser>
          <c:idx val="2"/>
          <c:order val="2"/>
          <c:tx>
            <c:strRef>
              <c:f>Sheet1!$D$11</c:f>
              <c:strCache>
                <c:ptCount val="1"/>
                <c:pt idx="0">
                  <c:v>≧pT2+VH(+)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Sheet1!$D$12</c:f>
              <c:numCache>
                <c:formatCode>General</c:formatCode>
                <c:ptCount val="1"/>
                <c:pt idx="0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AAC-4BBF-BE11-2CA71BFC32FA}"/>
            </c:ext>
          </c:extLst>
        </c:ser>
        <c:ser>
          <c:idx val="3"/>
          <c:order val="3"/>
          <c:tx>
            <c:strRef>
              <c:f>Sheet1!$E$11</c:f>
              <c:strCache>
                <c:ptCount val="1"/>
                <c:pt idx="0">
                  <c:v>preoperative URS+LVI(+)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satMod val="103000"/>
                    <a:lumMod val="102000"/>
                    <a:tint val="94000"/>
                  </a:schemeClr>
                </a:gs>
                <a:gs pos="50000">
                  <a:schemeClr val="accent4">
                    <a:satMod val="110000"/>
                    <a:lumMod val="100000"/>
                    <a:shade val="100000"/>
                  </a:schemeClr>
                </a:gs>
                <a:gs pos="100000">
                  <a:schemeClr val="accent4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Sheet1!$E$12</c:f>
              <c:numCache>
                <c:formatCode>General</c:formatCode>
                <c:ptCount val="1"/>
                <c:pt idx="0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AAC-4BBF-BE11-2CA71BFC32FA}"/>
            </c:ext>
          </c:extLst>
        </c:ser>
        <c:ser>
          <c:idx val="4"/>
          <c:order val="4"/>
          <c:tx>
            <c:strRef>
              <c:f>Sheet1!$F$11</c:f>
              <c:strCache>
                <c:ptCount val="1"/>
                <c:pt idx="0">
                  <c:v>preoperative URS+VH(+)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atMod val="103000"/>
                    <a:lumMod val="102000"/>
                    <a:tint val="94000"/>
                  </a:schemeClr>
                </a:gs>
                <a:gs pos="50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accent5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Sheet1!$F$1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AAC-4BBF-BE11-2CA71BFC32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82314336"/>
        <c:axId val="782315416"/>
      </c:barChart>
      <c:catAx>
        <c:axId val="782314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82315416"/>
        <c:crosses val="autoZero"/>
        <c:auto val="1"/>
        <c:lblAlgn val="ctr"/>
        <c:lblOffset val="100"/>
        <c:noMultiLvlLbl val="0"/>
      </c:catAx>
      <c:valAx>
        <c:axId val="7823154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8231433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16</c:f>
              <c:strCache>
                <c:ptCount val="1"/>
                <c:pt idx="0">
                  <c:v>≧pT2+preoperative URS+LVI(+)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7</c:f>
              <c:strCache>
                <c:ptCount val="1"/>
                <c:pt idx="0">
                  <c:v>3 risks</c:v>
                </c:pt>
              </c:strCache>
            </c:strRef>
          </c:cat>
          <c:val>
            <c:numRef>
              <c:f>Sheet1!$B$17</c:f>
              <c:numCache>
                <c:formatCode>General</c:formatCode>
                <c:ptCount val="1"/>
                <c:pt idx="0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61-4E8A-8D13-9A595624F037}"/>
            </c:ext>
          </c:extLst>
        </c:ser>
        <c:ser>
          <c:idx val="1"/>
          <c:order val="1"/>
          <c:tx>
            <c:strRef>
              <c:f>Sheet1!$C$16</c:f>
              <c:strCache>
                <c:ptCount val="1"/>
                <c:pt idx="0">
                  <c:v>≧pT2+LVI(+)+VH（+）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7</c:f>
              <c:strCache>
                <c:ptCount val="1"/>
                <c:pt idx="0">
                  <c:v>3 risks</c:v>
                </c:pt>
              </c:strCache>
            </c:strRef>
          </c:cat>
          <c:val>
            <c:numRef>
              <c:f>Sheet1!$C$17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D61-4E8A-8D13-9A595624F037}"/>
            </c:ext>
          </c:extLst>
        </c:ser>
        <c:ser>
          <c:idx val="2"/>
          <c:order val="2"/>
          <c:tx>
            <c:strRef>
              <c:f>Sheet1!$D$16</c:f>
              <c:strCache>
                <c:ptCount val="1"/>
                <c:pt idx="0">
                  <c:v>≧pT2+preoperative URS+VH(+)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Sheet1!$A$17</c:f>
              <c:strCache>
                <c:ptCount val="1"/>
                <c:pt idx="0">
                  <c:v>3 risks</c:v>
                </c:pt>
              </c:strCache>
            </c:strRef>
          </c:cat>
          <c:val>
            <c:numRef>
              <c:f>Sheet1!$D$17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D61-4E8A-8D13-9A595624F0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2113248"/>
        <c:axId val="382115048"/>
      </c:barChart>
      <c:catAx>
        <c:axId val="382113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82115048"/>
        <c:crosses val="autoZero"/>
        <c:auto val="1"/>
        <c:lblAlgn val="ctr"/>
        <c:lblOffset val="100"/>
        <c:noMultiLvlLbl val="0"/>
      </c:catAx>
      <c:valAx>
        <c:axId val="382115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821132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183'!$B$11</c:f>
              <c:strCache>
                <c:ptCount val="1"/>
                <c:pt idx="0">
                  <c:v>LVI(+) + eGFR&lt;5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'183'!$B$12</c:f>
              <c:numCache>
                <c:formatCode>General</c:formatCode>
                <c:ptCount val="1"/>
                <c:pt idx="0">
                  <c:v>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E0-4451-AA3F-89AB3E40CA88}"/>
            </c:ext>
          </c:extLst>
        </c:ser>
        <c:ser>
          <c:idx val="1"/>
          <c:order val="1"/>
          <c:tx>
            <c:strRef>
              <c:f>'183'!$C$11</c:f>
              <c:strCache>
                <c:ptCount val="1"/>
                <c:pt idx="0">
                  <c:v>RM(+) + eGFR&lt;50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'183'!$C$12</c:f>
              <c:numCache>
                <c:formatCode>General</c:formatCode>
                <c:ptCount val="1"/>
                <c:pt idx="0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0E0-4451-AA3F-89AB3E40CA88}"/>
            </c:ext>
          </c:extLst>
        </c:ser>
        <c:ser>
          <c:idx val="2"/>
          <c:order val="2"/>
          <c:tx>
            <c:strRef>
              <c:f>'183'!$D$11</c:f>
              <c:strCache>
                <c:ptCount val="1"/>
                <c:pt idx="0">
                  <c:v>pN(+) + eGFR&lt;50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'183'!$D$12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0E0-4451-AA3F-89AB3E40CA88}"/>
            </c:ext>
          </c:extLst>
        </c:ser>
        <c:ser>
          <c:idx val="3"/>
          <c:order val="3"/>
          <c:tx>
            <c:strRef>
              <c:f>'183'!$E$11</c:f>
              <c:strCache>
                <c:ptCount val="1"/>
                <c:pt idx="0">
                  <c:v>LVI(+) + RM(+)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satMod val="103000"/>
                    <a:lumMod val="102000"/>
                    <a:tint val="94000"/>
                  </a:schemeClr>
                </a:gs>
                <a:gs pos="50000">
                  <a:schemeClr val="accent4">
                    <a:satMod val="110000"/>
                    <a:lumMod val="100000"/>
                    <a:shade val="100000"/>
                  </a:schemeClr>
                </a:gs>
                <a:gs pos="100000">
                  <a:schemeClr val="accent4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'183'!$E$12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0E0-4451-AA3F-89AB3E40CA88}"/>
            </c:ext>
          </c:extLst>
        </c:ser>
        <c:ser>
          <c:idx val="4"/>
          <c:order val="4"/>
          <c:tx>
            <c:strRef>
              <c:f>'183'!$F$11</c:f>
              <c:strCache>
                <c:ptCount val="1"/>
                <c:pt idx="0">
                  <c:v>pN(+) + LVI(+)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atMod val="103000"/>
                    <a:lumMod val="102000"/>
                    <a:tint val="94000"/>
                  </a:schemeClr>
                </a:gs>
                <a:gs pos="50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accent5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2</c:f>
              <c:strCache>
                <c:ptCount val="1"/>
                <c:pt idx="0">
                  <c:v>2 risks</c:v>
                </c:pt>
              </c:strCache>
            </c:strRef>
          </c:cat>
          <c:val>
            <c:numRef>
              <c:f>'183'!$F$1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0E0-4451-AA3F-89AB3E40CA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82314336"/>
        <c:axId val="782315416"/>
      </c:barChart>
      <c:catAx>
        <c:axId val="782314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82315416"/>
        <c:crosses val="autoZero"/>
        <c:auto val="1"/>
        <c:lblAlgn val="ctr"/>
        <c:lblOffset val="100"/>
        <c:noMultiLvlLbl val="0"/>
      </c:catAx>
      <c:valAx>
        <c:axId val="78231541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8231433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183'!$B$8</c:f>
              <c:strCache>
                <c:ptCount val="1"/>
                <c:pt idx="0">
                  <c:v>eGFR&lt;5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9</c:f>
              <c:strCache>
                <c:ptCount val="1"/>
                <c:pt idx="0">
                  <c:v>1 risk </c:v>
                </c:pt>
              </c:strCache>
            </c:strRef>
          </c:cat>
          <c:val>
            <c:numRef>
              <c:f>'183'!$B$9</c:f>
              <c:numCache>
                <c:formatCode>General</c:formatCode>
                <c:ptCount val="1"/>
                <c:pt idx="0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4B-498F-B6D2-6CCABC02ABE6}"/>
            </c:ext>
          </c:extLst>
        </c:ser>
        <c:ser>
          <c:idx val="1"/>
          <c:order val="1"/>
          <c:tx>
            <c:strRef>
              <c:f>'183'!$C$8</c:f>
              <c:strCache>
                <c:ptCount val="1"/>
                <c:pt idx="0">
                  <c:v>LVI(+)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9</c:f>
              <c:strCache>
                <c:ptCount val="1"/>
                <c:pt idx="0">
                  <c:v>1 risk </c:v>
                </c:pt>
              </c:strCache>
            </c:strRef>
          </c:cat>
          <c:val>
            <c:numRef>
              <c:f>'183'!$C$9</c:f>
              <c:numCache>
                <c:formatCode>General</c:formatCode>
                <c:ptCount val="1"/>
                <c:pt idx="0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4B-498F-B6D2-6CCABC02ABE6}"/>
            </c:ext>
          </c:extLst>
        </c:ser>
        <c:ser>
          <c:idx val="2"/>
          <c:order val="2"/>
          <c:tx>
            <c:strRef>
              <c:f>'183'!$D$8</c:f>
              <c:strCache>
                <c:ptCount val="1"/>
                <c:pt idx="0">
                  <c:v>pN(+)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9</c:f>
              <c:strCache>
                <c:ptCount val="1"/>
                <c:pt idx="0">
                  <c:v>1 risk </c:v>
                </c:pt>
              </c:strCache>
            </c:strRef>
          </c:cat>
          <c:val>
            <c:numRef>
              <c:f>'183'!$D$9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84B-498F-B6D2-6CCABC02AB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26939000"/>
        <c:axId val="1326938280"/>
      </c:barChart>
      <c:catAx>
        <c:axId val="1326939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26938280"/>
        <c:crosses val="autoZero"/>
        <c:auto val="1"/>
        <c:lblAlgn val="ctr"/>
        <c:lblOffset val="100"/>
        <c:noMultiLvlLbl val="0"/>
      </c:catAx>
      <c:valAx>
        <c:axId val="13269382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2693900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183'!$B$16</c:f>
              <c:strCache>
                <c:ptCount val="1"/>
                <c:pt idx="0">
                  <c:v> LVI(+) + RM(+) + eGFR&lt;5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7</c:f>
              <c:strCache>
                <c:ptCount val="1"/>
                <c:pt idx="0">
                  <c:v>3 risks</c:v>
                </c:pt>
              </c:strCache>
            </c:strRef>
          </c:cat>
          <c:val>
            <c:numRef>
              <c:f>'183'!$B$17</c:f>
              <c:numCache>
                <c:formatCode>General</c:formatCode>
                <c:ptCount val="1"/>
                <c:pt idx="0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3B-427D-9807-A87E10FB03DD}"/>
            </c:ext>
          </c:extLst>
        </c:ser>
        <c:ser>
          <c:idx val="1"/>
          <c:order val="1"/>
          <c:tx>
            <c:strRef>
              <c:f>'183'!$C$16</c:f>
              <c:strCache>
                <c:ptCount val="1"/>
                <c:pt idx="0">
                  <c:v>pN(+) + LVI(+) + eGFR&lt;50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7</c:f>
              <c:strCache>
                <c:ptCount val="1"/>
                <c:pt idx="0">
                  <c:v>3 risks</c:v>
                </c:pt>
              </c:strCache>
            </c:strRef>
          </c:cat>
          <c:val>
            <c:numRef>
              <c:f>'183'!$C$17</c:f>
              <c:numCache>
                <c:formatCode>General</c:formatCode>
                <c:ptCount val="1"/>
                <c:pt idx="0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3B-427D-9807-A87E10FB03DD}"/>
            </c:ext>
          </c:extLst>
        </c:ser>
        <c:ser>
          <c:idx val="2"/>
          <c:order val="2"/>
          <c:tx>
            <c:strRef>
              <c:f>'183'!$D$16</c:f>
              <c:strCache>
                <c:ptCount val="1"/>
                <c:pt idx="0">
                  <c:v>pN(+) + RM(+) + eGFR&lt;50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7</c:f>
              <c:strCache>
                <c:ptCount val="1"/>
                <c:pt idx="0">
                  <c:v>3 risks</c:v>
                </c:pt>
              </c:strCache>
            </c:strRef>
          </c:cat>
          <c:val>
            <c:numRef>
              <c:f>'183'!$D$17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C3B-427D-9807-A87E10FB03DD}"/>
            </c:ext>
          </c:extLst>
        </c:ser>
        <c:ser>
          <c:idx val="3"/>
          <c:order val="3"/>
          <c:tx>
            <c:strRef>
              <c:f>'183'!$E$16</c:f>
              <c:strCache>
                <c:ptCount val="1"/>
                <c:pt idx="0">
                  <c:v>pN(+) + LVI(+) + RM(+)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satMod val="103000"/>
                    <a:lumMod val="102000"/>
                    <a:tint val="94000"/>
                  </a:schemeClr>
                </a:gs>
                <a:gs pos="50000">
                  <a:schemeClr val="accent4">
                    <a:satMod val="110000"/>
                    <a:lumMod val="100000"/>
                    <a:shade val="100000"/>
                  </a:schemeClr>
                </a:gs>
                <a:gs pos="100000">
                  <a:schemeClr val="accent4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183'!$A$17</c:f>
              <c:strCache>
                <c:ptCount val="1"/>
                <c:pt idx="0">
                  <c:v>3 risks</c:v>
                </c:pt>
              </c:strCache>
            </c:strRef>
          </c:cat>
          <c:val>
            <c:numRef>
              <c:f>'183'!$E$17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C3B-427D-9807-A87E10FB03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2113248"/>
        <c:axId val="382115048"/>
      </c:barChart>
      <c:catAx>
        <c:axId val="382113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82115048"/>
        <c:crosses val="autoZero"/>
        <c:auto val="1"/>
        <c:lblAlgn val="ctr"/>
        <c:lblOffset val="100"/>
        <c:noMultiLvlLbl val="0"/>
      </c:catAx>
      <c:valAx>
        <c:axId val="382115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2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821132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C5A1F2-6A9A-4701-9B12-1C8FAE6E725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288FA4-E7B6-417D-A4D5-095B4FC377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0478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EA5EC6-859E-C8C8-2DC8-7F49417C71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3DB9FEE-C650-16A9-6CFD-CE3F123751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A294BA-00BA-F6A1-7C6D-4E83C70EA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AA5CD5-CD0D-D1D7-8208-1B1A8A802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B3925E-B072-CB7E-157E-20E3ADFD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789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D3E701-8E43-6692-4AE2-83F0B07C69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AA78595-F460-2EBD-26A8-DFB406450B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E152B2-38D1-632B-13FD-60FEA3460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9C3D41-67F9-8860-08B2-61AA49FFB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A85428-C1B7-2B89-6952-850704956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303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B078A48-9D67-CA1D-30E6-2A09CEFC5C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A1F752B-D122-9E6C-6C54-21FFEB3CB3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22CED4-B38B-129A-7F00-8CE461B21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F5D3F4-6468-3D6B-9370-D34875230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9D8B05-1671-D221-C9A1-9F5798674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1714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AD8D1A-5D5E-01FD-07CB-814C954AC9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53D8FD7-C035-DE18-BC8E-C5DE3E220A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D1BFFD-1C9D-CF09-DA05-8E0427229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230EAF-B2D2-613B-3B12-2849D46A4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ED2D92-2925-D3F4-75FA-E72B9D2B6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513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66DBDF-115A-5123-0F66-915F69FCF9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67A4175-BC6E-8400-B7D7-4F3C45818C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67C7FF-343C-CF6F-D873-A86C115D0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23B9E6-A5D2-818C-6AC9-37C44EC0E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D5AA7D-A40D-7C38-D67F-55136FB21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5860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45CB13-40B9-DD24-009B-7C00C2A0D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423E4E-6D18-0836-E650-25DB63A031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134D5AB-D701-4600-092D-73EA45BDC7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FE463BA-4A36-A19D-56EC-A7A9B8E50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AEDF400-8863-9C52-DF16-1A8161D8D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CEC6B9A-061E-1505-5A41-D224E1344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0895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2E178C-E153-141A-EA32-29DE62F4E9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70CC494-49AC-9917-E9AA-0C04B6B9D8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5C2A79F-2ECC-4BC1-A16B-ABAC5C83FA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5D42B60-C75C-444A-459F-3128E19106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5C97198-78B5-619A-FDE5-5AEDFC9DE6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D0ADB1F-AE00-48A2-9B3E-BBDA4247A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3E6A17A-A8AF-3711-4083-779BC277F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612036F-DAEA-7EF5-692C-3DD5C04EB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877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9148DD-0FE8-44C9-5FEF-3DB470877B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0A47DE9-E072-E58A-1049-C8DC6A8C1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15C57F7-CBDF-F378-7D26-05607B4DC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82196CA-E690-4476-1E0F-0D52C99D4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424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7292DA0-9DD4-46C4-0A8E-82B1E9F5B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CA3D14B-DA49-7EBA-0E31-D62D08E6B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AA97FCE-1DFE-2EEB-BBAE-BDDF78621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4497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D9DDF9-4A9A-225E-B838-0407290D21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DDF67F-46E7-5DD2-DA52-EFCECDF5DC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0338206-CCDB-E39D-EB14-67D2B2ECA7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52816B-865E-DAF3-1CE5-5FA3A70FF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6055305-28A0-D900-78BE-3CC758785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BD9DF5D-8897-3BE4-8944-911DE98DD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3262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CECEE9-80E9-BEB4-0681-52760FA51B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0E539DB-EE4B-9CE3-39F3-3C8B650F0C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BCA257D-3429-384F-1A36-8F4EE0154B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C927A32-FF85-DA07-AB2D-794055DA0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6B638A-AD6F-6017-10A8-CD6F9B621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9A6CF3-9867-ED87-5C29-63107409D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165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2B892D1-8B4C-6EEF-E3E3-15C846DD2A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D158FBF-A431-1A01-AFD3-2968DB634D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03E61F-7E12-BCC9-3691-98E17DCB1B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35EEF7-6F65-435F-B64D-B73A970C49E4}" type="datetimeFigureOut">
              <a:rPr kumimoji="1" lang="ja-JP" altLang="en-US" smtClean="0"/>
              <a:t>2026/4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FF92D4-2A7C-5028-BD79-E38E1DB49A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7807BE-D4C8-37A4-1865-BE737C9E2A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4BC7E5-BE79-4858-854F-81C79C5C7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329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FA9A70-C2CC-56E5-D442-7365C75132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33AD388-76A5-025E-5875-7AC643938B32}"/>
              </a:ext>
            </a:extLst>
          </p:cNvPr>
          <p:cNvSpPr/>
          <p:nvPr/>
        </p:nvSpPr>
        <p:spPr>
          <a:xfrm>
            <a:off x="4285445" y="269825"/>
            <a:ext cx="2019574" cy="3858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U n=</a:t>
            </a:r>
            <a:r>
              <a:rPr lang="en-US" altLang="ja-JP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45</a:t>
            </a:r>
            <a:endParaRPr kumimoji="1" lang="ja-JP" altLang="en-US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BA3C31D0-19AF-689D-79C6-C1A89F0B9876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5295232" y="655706"/>
            <a:ext cx="0" cy="381316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F0CED400-3590-B98C-17FD-01287B753CE0}"/>
              </a:ext>
            </a:extLst>
          </p:cNvPr>
          <p:cNvCxnSpPr>
            <a:cxnSpLocks/>
          </p:cNvCxnSpPr>
          <p:nvPr/>
        </p:nvCxnSpPr>
        <p:spPr>
          <a:xfrm>
            <a:off x="5300742" y="2658313"/>
            <a:ext cx="187703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768A847-D7DF-9A30-A0C2-64FDC9FFD99B}"/>
              </a:ext>
            </a:extLst>
          </p:cNvPr>
          <p:cNvSpPr txBox="1"/>
          <p:nvPr/>
        </p:nvSpPr>
        <p:spPr>
          <a:xfrm>
            <a:off x="5605538" y="2221065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C4634A58-AA3B-1AA5-11E1-E326A28B0AD7}"/>
              </a:ext>
            </a:extLst>
          </p:cNvPr>
          <p:cNvSpPr/>
          <p:nvPr/>
        </p:nvSpPr>
        <p:spPr>
          <a:xfrm>
            <a:off x="7178877" y="2256390"/>
            <a:ext cx="2027248" cy="73399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nal cell carcinoma (n=</a:t>
            </a:r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CBD81FA8-92F1-D5EF-60F1-37C029BD4F8F}"/>
              </a:ext>
            </a:extLst>
          </p:cNvPr>
          <p:cNvCxnSpPr>
            <a:cxnSpLocks/>
          </p:cNvCxnSpPr>
          <p:nvPr/>
        </p:nvCxnSpPr>
        <p:spPr>
          <a:xfrm>
            <a:off x="5304008" y="1112612"/>
            <a:ext cx="187703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ABB02D16-8C27-AC70-AD12-E59BE857FB26}"/>
              </a:ext>
            </a:extLst>
          </p:cNvPr>
          <p:cNvSpPr/>
          <p:nvPr/>
        </p:nvSpPr>
        <p:spPr>
          <a:xfrm>
            <a:off x="7181045" y="811464"/>
            <a:ext cx="2027248" cy="5330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rt follow-up period (n=98)</a:t>
            </a:r>
            <a:endParaRPr kumimoji="1" lang="en-US" altLang="ja-JP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841F70A-09A8-B56F-FECE-E75A74F9F315}"/>
              </a:ext>
            </a:extLst>
          </p:cNvPr>
          <p:cNvSpPr txBox="1"/>
          <p:nvPr/>
        </p:nvSpPr>
        <p:spPr>
          <a:xfrm>
            <a:off x="5608804" y="743725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69B7B43D-82E4-CD46-94FF-242D0CEA33AB}"/>
              </a:ext>
            </a:extLst>
          </p:cNvPr>
          <p:cNvCxnSpPr>
            <a:cxnSpLocks/>
          </p:cNvCxnSpPr>
          <p:nvPr/>
        </p:nvCxnSpPr>
        <p:spPr>
          <a:xfrm>
            <a:off x="5300740" y="1747241"/>
            <a:ext cx="188252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D2903AC-DFD4-DDB2-3FDE-03E1BAF81640}"/>
              </a:ext>
            </a:extLst>
          </p:cNvPr>
          <p:cNvSpPr txBox="1"/>
          <p:nvPr/>
        </p:nvSpPr>
        <p:spPr>
          <a:xfrm>
            <a:off x="5605538" y="1399653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08FD33E2-BA25-0FF7-067B-0353B6C8C10B}"/>
              </a:ext>
            </a:extLst>
          </p:cNvPr>
          <p:cNvSpPr/>
          <p:nvPr/>
        </p:nvSpPr>
        <p:spPr>
          <a:xfrm>
            <a:off x="7169296" y="3180322"/>
            <a:ext cx="2027248" cy="5330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</a:t>
            </a:r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 </a:t>
            </a:r>
            <a:r>
              <a:rPr kumimoji="1"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39)</a:t>
            </a:r>
            <a:endParaRPr kumimoji="1" lang="ja-JP" altLang="en-US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43B70B5-57A2-FA12-37B2-6F2E731F8940}"/>
              </a:ext>
            </a:extLst>
          </p:cNvPr>
          <p:cNvSpPr txBox="1"/>
          <p:nvPr/>
        </p:nvSpPr>
        <p:spPr>
          <a:xfrm>
            <a:off x="5619834" y="2972249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60463D1-8F28-72A6-AFC2-FCAC7D483F32}"/>
              </a:ext>
            </a:extLst>
          </p:cNvPr>
          <p:cNvSpPr/>
          <p:nvPr/>
        </p:nvSpPr>
        <p:spPr>
          <a:xfrm>
            <a:off x="4317626" y="4486164"/>
            <a:ext cx="1953242" cy="59753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545</a:t>
            </a: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061411F5-A1E3-ED0E-640A-1CB6A204D249}"/>
              </a:ext>
            </a:extLst>
          </p:cNvPr>
          <p:cNvSpPr/>
          <p:nvPr/>
        </p:nvSpPr>
        <p:spPr>
          <a:xfrm>
            <a:off x="7177778" y="1545690"/>
            <a:ext cx="2973939" cy="5330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st or simultaneous cystectomy</a:t>
            </a:r>
          </a:p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=34)</a:t>
            </a:r>
            <a:endParaRPr kumimoji="1" lang="en-US" altLang="ja-JP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A2D95F20-61B3-9E71-D28E-938890B90776}"/>
              </a:ext>
            </a:extLst>
          </p:cNvPr>
          <p:cNvCxnSpPr>
            <a:cxnSpLocks/>
          </p:cNvCxnSpPr>
          <p:nvPr/>
        </p:nvCxnSpPr>
        <p:spPr>
          <a:xfrm>
            <a:off x="5295232" y="3368475"/>
            <a:ext cx="188252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A190F511-C91F-99FB-0A4E-477AED2D0F20}"/>
              </a:ext>
            </a:extLst>
          </p:cNvPr>
          <p:cNvSpPr/>
          <p:nvPr/>
        </p:nvSpPr>
        <p:spPr>
          <a:xfrm>
            <a:off x="7160838" y="3878637"/>
            <a:ext cx="2027248" cy="5330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vant therapy  </a:t>
            </a:r>
            <a:r>
              <a:rPr kumimoji="1"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</a:t>
            </a:r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r>
              <a:rPr kumimoji="1"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4BC8ADD-9FFD-795D-4591-1165E186292E}"/>
              </a:ext>
            </a:extLst>
          </p:cNvPr>
          <p:cNvSpPr txBox="1"/>
          <p:nvPr/>
        </p:nvSpPr>
        <p:spPr>
          <a:xfrm>
            <a:off x="5611376" y="3784736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DFF6E128-C3D6-C888-6A81-97ED24E1B57C}"/>
              </a:ext>
            </a:extLst>
          </p:cNvPr>
          <p:cNvCxnSpPr>
            <a:cxnSpLocks/>
          </p:cNvCxnSpPr>
          <p:nvPr/>
        </p:nvCxnSpPr>
        <p:spPr>
          <a:xfrm>
            <a:off x="5286774" y="4180962"/>
            <a:ext cx="188252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EE027211-5273-E5BC-EA20-CE165BB801A5}"/>
              </a:ext>
            </a:extLst>
          </p:cNvPr>
          <p:cNvSpPr/>
          <p:nvPr/>
        </p:nvSpPr>
        <p:spPr>
          <a:xfrm>
            <a:off x="5516521" y="5651266"/>
            <a:ext cx="3015827" cy="59753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eckMate</a:t>
            </a:r>
            <a:r>
              <a:rPr lang="en-US" altLang="ja-JP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74 criteria fit (N=183)</a:t>
            </a: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23719A25-3FD3-450A-60BE-B10929AF9B24}"/>
              </a:ext>
            </a:extLst>
          </p:cNvPr>
          <p:cNvSpPr/>
          <p:nvPr/>
        </p:nvSpPr>
        <p:spPr>
          <a:xfrm>
            <a:off x="2074133" y="5651266"/>
            <a:ext cx="3015827" cy="59753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eckMate274 criteria unfit (N=362)</a:t>
            </a: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FE33DB1B-4C9D-BE74-7A98-07EFDCD46149}"/>
              </a:ext>
            </a:extLst>
          </p:cNvPr>
          <p:cNvCxnSpPr>
            <a:cxnSpLocks/>
          </p:cNvCxnSpPr>
          <p:nvPr/>
        </p:nvCxnSpPr>
        <p:spPr>
          <a:xfrm>
            <a:off x="4684486" y="5083698"/>
            <a:ext cx="0" cy="56756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26EE120D-FBF2-D329-54AE-D63899EFD200}"/>
              </a:ext>
            </a:extLst>
          </p:cNvPr>
          <p:cNvCxnSpPr>
            <a:cxnSpLocks/>
          </p:cNvCxnSpPr>
          <p:nvPr/>
        </p:nvCxnSpPr>
        <p:spPr>
          <a:xfrm>
            <a:off x="6005668" y="5083698"/>
            <a:ext cx="0" cy="56756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385E43D-B55B-302A-B44C-E0CCF95F1933}"/>
              </a:ext>
            </a:extLst>
          </p:cNvPr>
          <p:cNvSpPr txBox="1"/>
          <p:nvPr/>
        </p:nvSpPr>
        <p:spPr>
          <a:xfrm>
            <a:off x="182880" y="239868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1054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3B3451E2-65A9-51A6-C6E5-8ADB2D625B26}"/>
              </a:ext>
            </a:extLst>
          </p:cNvPr>
          <p:cNvGraphicFramePr>
            <a:graphicFrameLocks/>
          </p:cNvGraphicFramePr>
          <p:nvPr/>
        </p:nvGraphicFramePr>
        <p:xfrm>
          <a:off x="559437" y="754380"/>
          <a:ext cx="3239453" cy="5829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49E4AC95-7ECF-0FE2-83B5-22CC41ECB8BC}"/>
              </a:ext>
            </a:extLst>
          </p:cNvPr>
          <p:cNvGraphicFramePr>
            <a:graphicFrameLocks/>
          </p:cNvGraphicFramePr>
          <p:nvPr/>
        </p:nvGraphicFramePr>
        <p:xfrm>
          <a:off x="4087176" y="777240"/>
          <a:ext cx="3616643" cy="6080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670F9C9-4335-44FC-C1A3-C992074057D7}"/>
              </a:ext>
            </a:extLst>
          </p:cNvPr>
          <p:cNvGraphicFramePr>
            <a:graphicFrameLocks/>
          </p:cNvGraphicFramePr>
          <p:nvPr/>
        </p:nvGraphicFramePr>
        <p:xfrm>
          <a:off x="7992104" y="788670"/>
          <a:ext cx="3357886" cy="55092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78B497A-B97B-60A9-7FE3-81B8CCBA49B6}"/>
              </a:ext>
            </a:extLst>
          </p:cNvPr>
          <p:cNvSpPr txBox="1"/>
          <p:nvPr/>
        </p:nvSpPr>
        <p:spPr>
          <a:xfrm>
            <a:off x="394103" y="108049"/>
            <a:ext cx="1108995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Distribution of specific risk factor or combinations according to the number of risk factors (risk number 1-3) in CM274 ineligible population.  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6138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BF54EBC-549B-B1DB-AF9E-D296DFD0EAB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CC37073-9951-EE3F-BBFF-6B6C01A126AE}"/>
              </a:ext>
            </a:extLst>
          </p:cNvPr>
          <p:cNvSpPr txBox="1"/>
          <p:nvPr/>
        </p:nvSpPr>
        <p:spPr>
          <a:xfrm>
            <a:off x="511492" y="125730"/>
            <a:ext cx="1108995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Distribution of specific risk factor or combinations according to the number of risk factors (risk number 1-3) in CM274 eligible population.  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A68F6CDE-3B22-4596-A9BE-061883DF2338}"/>
              </a:ext>
            </a:extLst>
          </p:cNvPr>
          <p:cNvGraphicFramePr>
            <a:graphicFrameLocks/>
          </p:cNvGraphicFramePr>
          <p:nvPr/>
        </p:nvGraphicFramePr>
        <p:xfrm>
          <a:off x="3510280" y="1074420"/>
          <a:ext cx="3496309" cy="58178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758142DD-681F-44FF-9115-D03CEB6C488D}"/>
              </a:ext>
            </a:extLst>
          </p:cNvPr>
          <p:cNvGraphicFramePr>
            <a:graphicFrameLocks/>
          </p:cNvGraphicFramePr>
          <p:nvPr/>
        </p:nvGraphicFramePr>
        <p:xfrm>
          <a:off x="488631" y="1108710"/>
          <a:ext cx="2998789" cy="4777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99FC2F41-3F11-4C4E-AEB9-8E65B3CB9F9F}"/>
              </a:ext>
            </a:extLst>
          </p:cNvPr>
          <p:cNvGraphicFramePr>
            <a:graphicFrameLocks/>
          </p:cNvGraphicFramePr>
          <p:nvPr/>
        </p:nvGraphicFramePr>
        <p:xfrm>
          <a:off x="7152321" y="1040130"/>
          <a:ext cx="3637599" cy="57264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4015291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C7D22EF040A00B4B9DF933B57484B575" ma:contentTypeVersion="1" ma:contentTypeDescription="新しいドキュメントを作成します。" ma:contentTypeScope="" ma:versionID="c2c6e272c29a435114dcf6f6fba9a05c">
  <xsd:schema xmlns:xsd="http://www.w3.org/2001/XMLSchema" xmlns:xs="http://www.w3.org/2001/XMLSchema" xmlns:p="http://schemas.microsoft.com/office/2006/metadata/properties" xmlns:ns3="545efed9-2545-4aff-9692-5a8efd50855a" targetNamespace="http://schemas.microsoft.com/office/2006/metadata/properties" ma:root="true" ma:fieldsID="8879fb76ddbba8c6c49a80923c4b8655" ns3:_="">
    <xsd:import namespace="545efed9-2545-4aff-9692-5a8efd50855a"/>
    <xsd:element name="properties">
      <xsd:complexType>
        <xsd:sequence>
          <xsd:element name="documentManagement">
            <xsd:complexType>
              <xsd:all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5efed9-2545-4aff-9692-5a8efd50855a" elementFormDefault="qualified">
    <xsd:import namespace="http://schemas.microsoft.com/office/2006/documentManagement/types"/>
    <xsd:import namespace="http://schemas.microsoft.com/office/infopath/2007/PartnerControls"/>
    <xsd:element name="MediaServiceDateTaken" ma:index="8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E76FBDE-0953-44BD-98A9-EB60D5E965C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2AD2B41-1F6C-41F8-9B9A-F28F35A9D560}">
  <ds:schemaRefs>
    <ds:schemaRef ds:uri="http://schemas.microsoft.com/office/infopath/2007/PartnerControls"/>
    <ds:schemaRef ds:uri="http://www.w3.org/XML/1998/namespace"/>
    <ds:schemaRef ds:uri="http://purl.org/dc/dcmitype/"/>
    <ds:schemaRef ds:uri="http://purl.org/dc/terms/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schemas.microsoft.com/office/2006/documentManagement/types"/>
    <ds:schemaRef ds:uri="545efed9-2545-4aff-9692-5a8efd50855a"/>
  </ds:schemaRefs>
</ds:datastoreItem>
</file>

<file path=customXml/itemProps3.xml><?xml version="1.0" encoding="utf-8"?>
<ds:datastoreItem xmlns:ds="http://schemas.openxmlformats.org/officeDocument/2006/customXml" ds:itemID="{9C59A746-2D30-4939-B9C1-39F90FE7DFA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45efed9-2545-4aff-9692-5a8efd50855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450</TotalTime>
  <Words>128</Words>
  <Application>Microsoft Office PowerPoint</Application>
  <PresentationFormat>ワイド画面</PresentationFormat>
  <Paragraphs>1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哲哉 進藤</dc:creator>
  <cp:lastModifiedBy>哲哉 進藤</cp:lastModifiedBy>
  <cp:revision>22</cp:revision>
  <cp:lastPrinted>2025-11-07T05:59:27Z</cp:lastPrinted>
  <dcterms:created xsi:type="dcterms:W3CDTF">2025-07-13T03:39:28Z</dcterms:created>
  <dcterms:modified xsi:type="dcterms:W3CDTF">2026-04-14T02:09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7D22EF040A00B4B9DF933B57484B575</vt:lpwstr>
  </property>
</Properties>
</file>